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1018" r:id="rId2"/>
    <p:sldId id="101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7"/>
    <p:restoredTop sz="94676"/>
  </p:normalViewPr>
  <p:slideViewPr>
    <p:cSldViewPr snapToGrid="0">
      <p:cViewPr varScale="1">
        <p:scale>
          <a:sx n="97" d="100"/>
          <a:sy n="97" d="100"/>
        </p:scale>
        <p:origin x="9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DB7803-B363-85FB-1DF6-8D03604248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F028F2-9635-8423-3DB2-ABC3BDB944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2B582C-BE71-F3FF-C558-F7BBB490A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0A27E7-9529-BEA6-E076-B9AF1A21D8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12DA54-86FD-453E-0329-18C79FD1D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944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7734E1-B31A-DC46-7B47-2ED557570B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8220CB-9495-6078-28D4-CCC7149B8A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D66BEF-A53A-EA62-A602-BB7BDDB1A6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E7C0A5-5F6F-7330-F9CA-CDFB98149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275BA5-3AB3-DF0D-1B77-4B29E8D5C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216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18BE48-1F99-6EC4-8D57-AB0A36855C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D0CB39-AA64-AD32-D9E9-33C7ADF6A4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10DF0E-CC75-F3DD-FE39-5ED5EA717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0C2E54-49BF-F7D4-EE86-442A5C693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ACBFB2-7970-2B7E-55CD-B8D2C326F0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380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443640-83A7-4955-2E36-2D709A0C46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E409BF-ADCA-4F63-2B6C-972A73A3AA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6ED011-40B6-3448-85EF-CF782AAD5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38394A-D74D-15F1-ECFA-39B9D1668E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700F3E-075D-96B7-DFA7-6812D74B9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25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2D91D8-B588-1F28-80BE-AD8CD7BAD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54EE37-D653-E20C-60CB-662DE26F33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AA70B0-63FF-0DDD-5482-DFAEF24F7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DF78FB-0266-4FB8-7A49-85F3F2BA2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121D04-E942-EE28-D823-A6FB87ED5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457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1FA60-0142-C258-68DA-F7AF59AFD8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4353EF-39FB-2C77-EBBC-662D90C4DF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6A6A1F-47B3-BB90-6770-499CA5CA44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570EB5-AF3B-9AC9-CA9E-01AD93D36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7FC2F2-347B-AA55-B5CB-9786E964C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F3B70B-33A2-2C9D-BE91-2FC10D8B4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30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FFB7B3-5D78-299A-3F22-AB95FC129B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C3EBEF-2CAC-A103-37E1-1E1091BAA3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F1FD31-998A-A05B-E199-482D58693E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385111-5DB8-9D00-CDF3-3F14AB2495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E3C8EC-0078-CB55-89A8-8A78D77232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EB2F02C-B6FC-5DE1-811C-E1DFBB97A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CAF4B6-D07E-7E56-2470-81E6F7DD87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AF4024-4140-F113-B943-F0226E3E3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14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0A20F0-E64D-AD44-8E54-407615B730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A33731-CE1A-6DA2-508D-31FA8C96D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5CAB6C-2AE8-646F-6DB8-2FF1FDACD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FF713F-167D-1902-5309-15F1DEC0D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746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88D706-BC61-6946-B517-A2C7219B1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642C2E6-CB4F-819F-5677-42C8EB659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AD22007-B50D-38A9-B706-A891AF226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688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E4711E-7337-1F48-F137-4C37B1558B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3060F2-F154-2F0E-A4AE-D8CB467270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E8F1B9-4BC0-19E7-E95F-0EC76729B0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2B002E-FD5C-9AF6-9771-EEBBA19E8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AA8624-03E9-F6DB-62E4-A6B2C9990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D64F95-2EE9-EE4F-349D-C37AB43C3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111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A54FA3-8137-5E0A-F292-32DF6E374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88A660E-25E5-9154-438F-E8AB1207AB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7ADE9D-3FF9-AF6A-A380-CB3DCC1A65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8C19EE-A866-08F3-6B69-5EEFD8AD8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8FD6CC-AB09-C481-BE7A-367511100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313DD2-C8F4-861F-B986-5E699F24E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443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7046FD-418D-EF53-B7F2-16410136DC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1CEC48-964C-8E3F-D02B-209CE5469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303F01-C6A9-3231-8E78-90EE6CB032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5166F6A-7C62-F849-9A6A-AC2C6E321CE4}" type="datetimeFigureOut">
              <a:rPr lang="en-US" smtClean="0"/>
              <a:t>7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5D5325-6391-083D-E82D-B42053AF23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91AD3-7E4E-7B7A-7F1C-AA676ACB36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4BC5D5-33A8-FC42-83F5-51C5EAAB6C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514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64357202-6F74-3764-ED7B-33974EBB91B4}"/>
              </a:ext>
            </a:extLst>
          </p:cNvPr>
          <p:cNvSpPr txBox="1"/>
          <p:nvPr/>
        </p:nvSpPr>
        <p:spPr>
          <a:xfrm>
            <a:off x="3113830" y="863658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81BC5EF-2262-6784-1908-C7CD87B713ED}"/>
              </a:ext>
            </a:extLst>
          </p:cNvPr>
          <p:cNvSpPr txBox="1"/>
          <p:nvPr/>
        </p:nvSpPr>
        <p:spPr>
          <a:xfrm>
            <a:off x="4220926" y="863658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1D2A3E4-796B-9084-E7A0-71919119D34D}"/>
              </a:ext>
            </a:extLst>
          </p:cNvPr>
          <p:cNvSpPr txBox="1"/>
          <p:nvPr/>
        </p:nvSpPr>
        <p:spPr>
          <a:xfrm>
            <a:off x="5225168" y="859883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EB69A07-6D10-23A2-01DC-DF5180374986}"/>
              </a:ext>
            </a:extLst>
          </p:cNvPr>
          <p:cNvSpPr txBox="1"/>
          <p:nvPr/>
        </p:nvSpPr>
        <p:spPr>
          <a:xfrm>
            <a:off x="6467356" y="863658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2532AB9-B76C-396B-BB06-1BEF7E7AB5FC}"/>
              </a:ext>
            </a:extLst>
          </p:cNvPr>
          <p:cNvSpPr txBox="1"/>
          <p:nvPr/>
        </p:nvSpPr>
        <p:spPr>
          <a:xfrm>
            <a:off x="7264178" y="863658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D5FE677-BFC5-294D-A4F7-6B2ED2551EFC}"/>
              </a:ext>
            </a:extLst>
          </p:cNvPr>
          <p:cNvSpPr txBox="1"/>
          <p:nvPr/>
        </p:nvSpPr>
        <p:spPr>
          <a:xfrm>
            <a:off x="8184531" y="867905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37D24F9-6AFF-3E5D-A1EA-B139675CC3F9}"/>
              </a:ext>
            </a:extLst>
          </p:cNvPr>
          <p:cNvSpPr txBox="1"/>
          <p:nvPr/>
        </p:nvSpPr>
        <p:spPr>
          <a:xfrm>
            <a:off x="8934589" y="867905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96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F3EFC0A0-D42B-441C-E671-6C44AC437D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6215501"/>
              </p:ext>
            </p:extLst>
          </p:nvPr>
        </p:nvGraphicFramePr>
        <p:xfrm>
          <a:off x="3802419" y="1547431"/>
          <a:ext cx="4924142" cy="33551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602438" imgH="2454810" progId="Prism10.Document">
                  <p:embed/>
                </p:oleObj>
              </mc:Choice>
              <mc:Fallback>
                <p:oleObj name="Prism 10" r:id="rId2" imgW="3602438" imgH="2454810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F3EFC0A0-D42B-441C-E671-6C44AC437D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02419" y="1547431"/>
                        <a:ext cx="4924142" cy="33551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7298EAC-E0E0-168F-488B-B52978A8663E}"/>
              </a:ext>
            </a:extLst>
          </p:cNvPr>
          <p:cNvCxnSpPr/>
          <p:nvPr/>
        </p:nvCxnSpPr>
        <p:spPr>
          <a:xfrm>
            <a:off x="5764591" y="2165655"/>
            <a:ext cx="555567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Oval 25">
            <a:extLst>
              <a:ext uri="{FF2B5EF4-FFF2-40B4-BE49-F238E27FC236}">
                <a16:creationId xmlns:a16="http://schemas.microsoft.com/office/drawing/2014/main" id="{59214962-D1C8-FECB-4F2E-7F1C92971C00}"/>
              </a:ext>
            </a:extLst>
          </p:cNvPr>
          <p:cNvSpPr/>
          <p:nvPr/>
        </p:nvSpPr>
        <p:spPr>
          <a:xfrm>
            <a:off x="5925286" y="2086215"/>
            <a:ext cx="206478" cy="139966"/>
          </a:xfrm>
          <a:prstGeom prst="ellipse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AAC94FF9-46FA-A493-C073-84A9BAF77A98}"/>
              </a:ext>
            </a:extLst>
          </p:cNvPr>
          <p:cNvCxnSpPr>
            <a:cxnSpLocks/>
          </p:cNvCxnSpPr>
          <p:nvPr/>
        </p:nvCxnSpPr>
        <p:spPr>
          <a:xfrm>
            <a:off x="5764591" y="1851330"/>
            <a:ext cx="5555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Oval 31">
            <a:extLst>
              <a:ext uri="{FF2B5EF4-FFF2-40B4-BE49-F238E27FC236}">
                <a16:creationId xmlns:a16="http://schemas.microsoft.com/office/drawing/2014/main" id="{35ABBFBC-FBA1-E83D-9BA4-65B32CB5D2E5}"/>
              </a:ext>
            </a:extLst>
          </p:cNvPr>
          <p:cNvSpPr/>
          <p:nvPr/>
        </p:nvSpPr>
        <p:spPr>
          <a:xfrm>
            <a:off x="5934617" y="1792796"/>
            <a:ext cx="206478" cy="139966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34604EB-42DA-09F5-629D-761936400EFE}"/>
              </a:ext>
            </a:extLst>
          </p:cNvPr>
          <p:cNvSpPr txBox="1"/>
          <p:nvPr/>
        </p:nvSpPr>
        <p:spPr>
          <a:xfrm>
            <a:off x="6317648" y="1708392"/>
            <a:ext cx="26169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4C0EA6E-E068-0306-6330-6C74D10529FB}"/>
              </a:ext>
            </a:extLst>
          </p:cNvPr>
          <p:cNvSpPr txBox="1"/>
          <p:nvPr/>
        </p:nvSpPr>
        <p:spPr>
          <a:xfrm>
            <a:off x="6330509" y="2027155"/>
            <a:ext cx="2075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e-operative hindlim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3D1AEB3-8FBF-C606-53FC-A757794CDF7F}"/>
              </a:ext>
            </a:extLst>
          </p:cNvPr>
          <p:cNvSpPr txBox="1"/>
          <p:nvPr/>
        </p:nvSpPr>
        <p:spPr>
          <a:xfrm rot="16200000">
            <a:off x="2218164" y="3023024"/>
            <a:ext cx="30910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luorescence intensity (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.u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773099B-E52C-C4AE-4A4A-01D2E5F5C7DC}"/>
              </a:ext>
            </a:extLst>
          </p:cNvPr>
          <p:cNvSpPr txBox="1"/>
          <p:nvPr/>
        </p:nvSpPr>
        <p:spPr>
          <a:xfrm>
            <a:off x="5353560" y="4728787"/>
            <a:ext cx="18083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alf-life (hours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0C21600-A924-FEA0-B2C7-EF8709075B51}"/>
              </a:ext>
            </a:extLst>
          </p:cNvPr>
          <p:cNvSpPr txBox="1"/>
          <p:nvPr/>
        </p:nvSpPr>
        <p:spPr>
          <a:xfrm>
            <a:off x="9699586" y="6511820"/>
            <a:ext cx="26060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4132461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0B8E21-D9DE-BE57-B7AE-1A0B9BB247A1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838199" y="1825625"/>
            <a:ext cx="10722429" cy="42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>
              <a:buNone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uorescein clearance was measured pre-operatively in the operated hindlimb and the non-irradiated control hindlimb over 96 hours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991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46</Words>
  <Application>Microsoft Macintosh PowerPoint</Application>
  <PresentationFormat>Widescreen</PresentationFormat>
  <Paragraphs>13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rism 10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hmed, Shahnur</dc:creator>
  <cp:lastModifiedBy>Ahmed, Shahnur</cp:lastModifiedBy>
  <cp:revision>4</cp:revision>
  <dcterms:created xsi:type="dcterms:W3CDTF">2025-07-15T20:01:23Z</dcterms:created>
  <dcterms:modified xsi:type="dcterms:W3CDTF">2025-07-17T19:48:38Z</dcterms:modified>
</cp:coreProperties>
</file>